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5" r:id="rId3"/>
    <p:sldId id="274" r:id="rId4"/>
    <p:sldId id="267" r:id="rId5"/>
    <p:sldId id="285" r:id="rId6"/>
    <p:sldId id="296" r:id="rId7"/>
    <p:sldId id="286" r:id="rId8"/>
    <p:sldId id="297" r:id="rId9"/>
    <p:sldId id="298" r:id="rId10"/>
    <p:sldId id="299" r:id="rId11"/>
    <p:sldId id="300" r:id="rId12"/>
    <p:sldId id="301" r:id="rId13"/>
    <p:sldId id="302" r:id="rId14"/>
  </p:sldIdLst>
  <p:sldSz cx="648017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4" d="100"/>
          <a:sy n="104" d="100"/>
        </p:scale>
        <p:origin x="948" y="-5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wmf"/><Relationship Id="rId1" Type="http://schemas.openxmlformats.org/officeDocument/2006/relationships/image" Target="../media/image8.w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image" Target="../media/image11.wmf"/><Relationship Id="rId1" Type="http://schemas.openxmlformats.org/officeDocument/2006/relationships/image" Target="../media/image10.w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wmf"/><Relationship Id="rId1" Type="http://schemas.openxmlformats.org/officeDocument/2006/relationships/image" Target="../media/image13.w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wmf"/><Relationship Id="rId2" Type="http://schemas.openxmlformats.org/officeDocument/2006/relationships/image" Target="../media/image16.wmf"/><Relationship Id="rId1" Type="http://schemas.openxmlformats.org/officeDocument/2006/relationships/image" Target="../media/image15.w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19.wmf"/><Relationship Id="rId1" Type="http://schemas.openxmlformats.org/officeDocument/2006/relationships/image" Target="../media/image18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090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71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313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4412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207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289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4518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2712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99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1478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4674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82ADB-CDEB-4D99-A942-7296BACA18FF}" type="datetimeFigureOut">
              <a:rPr lang="zh-CN" altLang="en-US" smtClean="0"/>
              <a:t>2022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73093-B098-485E-A32A-90585B887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5972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6.xml"/><Relationship Id="rId1" Type="http://schemas.openxmlformats.org/officeDocument/2006/relationships/tags" Target="../tags/tag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6.xml"/><Relationship Id="rId1" Type="http://schemas.openxmlformats.org/officeDocument/2006/relationships/tags" Target="../tags/tag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w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8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w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1.w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10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4.wmf"/><Relationship Id="rId5" Type="http://schemas.openxmlformats.org/officeDocument/2006/relationships/oleObject" Target="../embeddings/oleObject14.bin"/><Relationship Id="rId4" Type="http://schemas.openxmlformats.org/officeDocument/2006/relationships/image" Target="../media/image13.w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w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6.w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15.w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19.w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18.w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6.xml"/><Relationship Id="rId1" Type="http://schemas.openxmlformats.org/officeDocument/2006/relationships/tags" Target="../tags/tag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10" name="组合 3"/>
          <p:cNvGrpSpPr/>
          <p:nvPr/>
        </p:nvGrpSpPr>
        <p:grpSpPr>
          <a:xfrm>
            <a:off x="1071468" y="1905807"/>
            <a:ext cx="4443178" cy="4003899"/>
            <a:chOff x="1026" y="2372"/>
            <a:chExt cx="11796" cy="9352"/>
          </a:xfrm>
        </p:grpSpPr>
        <p:graphicFrame>
          <p:nvGraphicFramePr>
            <p:cNvPr id="17411" name="对象 4"/>
            <p:cNvGraphicFramePr/>
            <p:nvPr/>
          </p:nvGraphicFramePr>
          <p:xfrm>
            <a:off x="1026" y="2372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8" r:id="rId3" imgW="4276725" imgH="3023235" progId="Origin50.Graph">
                    <p:embed/>
                  </p:oleObj>
                </mc:Choice>
                <mc:Fallback>
                  <p:oleObj r:id="rId3" imgW="4276725" imgH="3023235" progId="Origin50.Graph">
                    <p:embed/>
                    <p:pic>
                      <p:nvPicPr>
                        <p:cNvPr id="17411" name="对象 4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26" y="2372"/>
                          <a:ext cx="5669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412" name="对象 9"/>
            <p:cNvGraphicFramePr/>
            <p:nvPr/>
          </p:nvGraphicFramePr>
          <p:xfrm>
            <a:off x="7153" y="2372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9" r:id="rId5" imgW="4276725" imgH="3023235" progId="Origin50.Graph">
                    <p:embed/>
                  </p:oleObj>
                </mc:Choice>
                <mc:Fallback>
                  <p:oleObj r:id="rId5" imgW="4276725" imgH="3023235" progId="Origin50.Graph">
                    <p:embed/>
                    <p:pic>
                      <p:nvPicPr>
                        <p:cNvPr id="17412" name="对象 9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153" y="2372"/>
                          <a:ext cx="5669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413" name="对象 11"/>
            <p:cNvGraphicFramePr/>
            <p:nvPr/>
          </p:nvGraphicFramePr>
          <p:xfrm>
            <a:off x="1026" y="7189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0" r:id="rId7" imgW="4276725" imgH="3023235" progId="Origin50.Graph">
                    <p:embed/>
                  </p:oleObj>
                </mc:Choice>
                <mc:Fallback>
                  <p:oleObj r:id="rId7" imgW="4276725" imgH="3023235" progId="Origin50.Graph">
                    <p:embed/>
                    <p:pic>
                      <p:nvPicPr>
                        <p:cNvPr id="17413" name="对象 1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026" y="7189"/>
                          <a:ext cx="5669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414" name="对象 13"/>
            <p:cNvGraphicFramePr/>
            <p:nvPr/>
          </p:nvGraphicFramePr>
          <p:xfrm>
            <a:off x="7153" y="7189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1" r:id="rId9" imgW="4276725" imgH="3023235" progId="Origin50.Graph">
                    <p:embed/>
                  </p:oleObj>
                </mc:Choice>
                <mc:Fallback>
                  <p:oleObj r:id="rId9" imgW="4276725" imgH="3023235" progId="Origin50.Graph">
                    <p:embed/>
                    <p:pic>
                      <p:nvPicPr>
                        <p:cNvPr id="17414" name="对象 13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7153" y="7189"/>
                          <a:ext cx="5669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7415" name="文本框 6"/>
          <p:cNvSpPr txBox="1"/>
          <p:nvPr/>
        </p:nvSpPr>
        <p:spPr>
          <a:xfrm>
            <a:off x="665818" y="6243193"/>
            <a:ext cx="5081256" cy="124649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fontAlgn="base">
              <a:spcBef>
                <a:spcPts val="600"/>
              </a:spcBef>
              <a:spcAft>
                <a:spcPts val="1200"/>
              </a:spcAft>
            </a:pPr>
            <a:r>
              <a:rPr lang="en-US" altLang="zh-CN" sz="1000" dirty="0">
                <a:latin typeface="Times New Roman" panose="02020603050405020304" pitchFamily="18" charset="0"/>
              </a:rPr>
              <a:t>Supplementary Figure 1. Relative mRNA abundance of </a:t>
            </a:r>
            <a:r>
              <a:rPr lang="en-US" altLang="zh-CN" sz="1000" i="1" dirty="0">
                <a:latin typeface="Times New Roman" panose="02020603050405020304" pitchFamily="18" charset="0"/>
              </a:rPr>
              <a:t>FBA1, RCA1, FBP5, </a:t>
            </a:r>
            <a:r>
              <a:rPr lang="en-US" altLang="zh-CN" sz="1000" dirty="0">
                <a:latin typeface="Times New Roman" panose="02020603050405020304" pitchFamily="18" charset="0"/>
              </a:rPr>
              <a:t>and </a:t>
            </a:r>
            <a:r>
              <a:rPr lang="en-US" altLang="zh-CN" sz="1000" i="1" dirty="0">
                <a:latin typeface="Times New Roman" panose="02020603050405020304" pitchFamily="18" charset="0"/>
              </a:rPr>
              <a:t>PGK1</a:t>
            </a:r>
            <a:r>
              <a:rPr lang="en-US" altLang="zh-CN" sz="1000" dirty="0">
                <a:latin typeface="Times New Roman" panose="02020603050405020304" pitchFamily="18" charset="0"/>
              </a:rPr>
              <a:t> in </a:t>
            </a:r>
            <a:r>
              <a:rPr lang="en-US" altLang="zh-CN" sz="1000" i="1" dirty="0">
                <a:latin typeface="Times New Roman" panose="02020603050405020304" pitchFamily="18" charset="0"/>
              </a:rPr>
              <a:t>FBA1-, RCA1-, FBP5-, </a:t>
            </a:r>
            <a:r>
              <a:rPr lang="en-US" altLang="zh-CN" sz="1000" dirty="0">
                <a:latin typeface="Times New Roman" panose="02020603050405020304" pitchFamily="18" charset="0"/>
              </a:rPr>
              <a:t>and</a:t>
            </a:r>
            <a:r>
              <a:rPr lang="en-US" altLang="zh-CN" sz="1000" i="1" dirty="0">
                <a:latin typeface="Times New Roman" panose="02020603050405020304" pitchFamily="18" charset="0"/>
              </a:rPr>
              <a:t> PGK1- </a:t>
            </a:r>
            <a:r>
              <a:rPr lang="en-US" altLang="zh-CN" sz="1000" dirty="0">
                <a:latin typeface="Times New Roman" panose="02020603050405020304" pitchFamily="18" charset="0"/>
              </a:rPr>
              <a:t>silencing plants. Plants infected with empty TRV2 vector named TRV were used as control. The data show the average of twelve biological replicates(±SD). Different letters represent significant differences (P&lt;0.05) according to Tukey’s test.</a:t>
            </a:r>
            <a:endParaRPr lang="zh-CN" altLang="zh-CN" sz="1000" dirty="0">
              <a:latin typeface="Times New Roman" panose="02020603050405020304" pitchFamily="18" charset="0"/>
            </a:endParaRPr>
          </a:p>
          <a:p>
            <a:endParaRPr lang="zh-CN" altLang="en-US" sz="15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01348" y="1353102"/>
            <a:ext cx="4422596" cy="2955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</a:rPr>
              <a:t>Supplementary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3 Primers used for yeast one-hybrid assays</a:t>
            </a:r>
            <a:endParaRPr lang="zh-CN" altLang="zh-CN" sz="10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/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2936538888"/>
              </p:ext>
            </p:extLst>
          </p:nvPr>
        </p:nvGraphicFramePr>
        <p:xfrm>
          <a:off x="773779" y="1905895"/>
          <a:ext cx="4859989" cy="1977047"/>
        </p:xfrm>
        <a:graphic>
          <a:graphicData uri="http://schemas.openxmlformats.org/drawingml/2006/table">
            <a:tbl>
              <a:tblPr firstRow="1" firstCol="1" bandRow="1"/>
              <a:tblGrid>
                <a:gridCol w="4947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281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254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116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65095"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able 3 Primers used for yeast one-hybrid assays</a:t>
                      </a:r>
                    </a:p>
                  </a:txBody>
                  <a:tcPr marL="33196" marR="3319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Genes</a:t>
                      </a:r>
                    </a:p>
                  </a:txBody>
                  <a:tcPr marL="33196" marR="3319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ccession number</a:t>
                      </a:r>
                    </a:p>
                  </a:txBody>
                  <a:tcPr marL="33196" marR="3319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orward primers (5’-3’)</a:t>
                      </a:r>
                    </a:p>
                  </a:txBody>
                  <a:tcPr marL="33196" marR="3319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Reverse primers (5’-3’)</a:t>
                      </a:r>
                    </a:p>
                  </a:txBody>
                  <a:tcPr marL="33196" marR="3319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3992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BZR1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4g079980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CcatatgATGTGGGAAGGTGGAGGGTTG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</a:rPr>
                        <a:t>CGCcccgggTCACATCCGAGCAGTCCCAC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3992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BA1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1g110360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ttgaattcgagctcggtaccGCATCTTCAATGGTTCTGCCTT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acagagcacatgcctcgagTTAGCAACCACCCTGCAACAG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0988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RCA1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9g011080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ttgaattcgagctcggtaccACAAGTAAAAATGATACTATAATTAATATATGTAATTAA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acagagcacatgcctcgagAGAAAGTCTAAGCATATTCTTTCAAAATTC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0988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BP5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10g086720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ttgaattcgagctcggtaccTGTTGACTAATCTTAGGCTCCTTCC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acagagcacatgcctcgagATTATAATTTGATTATAGCCGAAAAATACC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3992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PGK1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7g066610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ttgaattcgagctcggtaccATTCACCAGCAAATCGTCGAA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acagagcacatgcctcgagGCTTGAATGCCGATGATTTGA</a:t>
                      </a:r>
                    </a:p>
                  </a:txBody>
                  <a:tcPr marL="33196" marR="331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39992" y="1199638"/>
            <a:ext cx="3869574" cy="2955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</a:rPr>
              <a:t>Supplementary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4 Primers used for dual-luciferase assays</a:t>
            </a:r>
            <a:endParaRPr lang="zh-CN" altLang="zh-CN" sz="10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2686431045"/>
              </p:ext>
            </p:extLst>
          </p:nvPr>
        </p:nvGraphicFramePr>
        <p:xfrm>
          <a:off x="682219" y="1863432"/>
          <a:ext cx="5131481" cy="2064737"/>
        </p:xfrm>
        <a:graphic>
          <a:graphicData uri="http://schemas.openxmlformats.org/drawingml/2006/table">
            <a:tbl>
              <a:tblPr firstRow="1" firstCol="1" bandRow="1"/>
              <a:tblGrid>
                <a:gridCol w="4218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44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407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59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583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66124">
                <a:tc gridSpan="5">
                  <a:txBody>
                    <a:bodyPr/>
                    <a:lstStyle/>
                    <a:p>
                      <a:pPr algn="ctr"/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able 4 Primers used for dual-luciferase assays</a:t>
                      </a:r>
                    </a:p>
                  </a:txBody>
                  <a:tcPr marL="32661" marR="3266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2625"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Genes</a:t>
                      </a:r>
                    </a:p>
                  </a:txBody>
                  <a:tcPr marL="32661" marR="3266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ccession number</a:t>
                      </a:r>
                    </a:p>
                  </a:txBody>
                  <a:tcPr marL="32661" marR="3266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orward primers (5’-3’)</a:t>
                      </a:r>
                    </a:p>
                  </a:txBody>
                  <a:tcPr marL="32661" marR="3266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Reverse primers (5’-3’)</a:t>
                      </a:r>
                    </a:p>
                  </a:txBody>
                  <a:tcPr marL="32661" marR="3266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6250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BZR1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4g079980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gctctagaactagtggatccATGTGGGAAGG TGGAGGGTT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gatttcagcgaattggtaccTCACATCCGAG CAGTCCCAC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6250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BA1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1g110360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ccactagttctagagcggccgcGCATCTTCAATGGTTCTGCCTT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gtttttggcgtcttccatggGACAAAAACCTGTTTTCTTATACTAGTTGT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0988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RCA1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9g011080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ccactagttctagagcggccgcACAAGTAAAAATGATACTATAATTAATATATGTAATTAA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gtttttggcgtcttccatggAAGTAAGGGAAGTGCTAAGTTTTATAGC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6250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BP5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10g086720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ccactagttctagagcggccgcTGTTGACTAATCTTAGGCTCCTTCC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gtttttggcgtcttccatggATACACACTACTACTCTGTCTCTTAGCCTCT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6250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PGK1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7g066610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ccactagttctagagcggccgcAAATCTCTGGAAGATGAATCAAATTTC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gtttttggcgtcttccatggCTTTCCACCACAAAATTCAACTTACT</a:t>
                      </a:r>
                    </a:p>
                  </a:txBody>
                  <a:tcPr marL="32661" marR="326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816469" y="1055309"/>
            <a:ext cx="3709116" cy="2955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</a:rPr>
              <a:t>Supplementary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5 Primers used for </a:t>
            </a:r>
            <a:r>
              <a:rPr lang="en-US" altLang="zh-CN" sz="10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qPCR assays</a:t>
            </a:r>
            <a:endParaRPr lang="zh-CN" altLang="zh-CN" sz="10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/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1114670688"/>
              </p:ext>
            </p:extLst>
          </p:nvPr>
        </p:nvGraphicFramePr>
        <p:xfrm>
          <a:off x="709970" y="1693181"/>
          <a:ext cx="4990113" cy="1363494"/>
        </p:xfrm>
        <a:graphic>
          <a:graphicData uri="http://schemas.openxmlformats.org/drawingml/2006/table">
            <a:tbl>
              <a:tblPr firstRow="1" firstCol="1" bandRow="1"/>
              <a:tblGrid>
                <a:gridCol w="4601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0962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3962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807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7249"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able 5 Primers used for </a:t>
                      </a:r>
                      <a:r>
                        <a:rPr lang="en-US" sz="1000" b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hIP</a:t>
                      </a: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-qPCR assays</a:t>
                      </a:r>
                    </a:p>
                  </a:txBody>
                  <a:tcPr marL="40499" marR="404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7249"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Genes</a:t>
                      </a:r>
                    </a:p>
                  </a:txBody>
                  <a:tcPr marL="40499" marR="404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ccession number</a:t>
                      </a:r>
                    </a:p>
                  </a:txBody>
                  <a:tcPr marL="40499" marR="404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orward primers(5’-3’)</a:t>
                      </a:r>
                    </a:p>
                  </a:txBody>
                  <a:tcPr marL="40499" marR="404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Reverse primers(5’-3’)</a:t>
                      </a:r>
                    </a:p>
                  </a:txBody>
                  <a:tcPr marL="40499" marR="404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7249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BA1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1g110360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CGCTTGACCTCATTTCT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CATGCCGTGGTCCAATAT</a:t>
                      </a:r>
                    </a:p>
                  </a:txBody>
                  <a:tcPr marL="40499" marR="404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7249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RCA1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9g011080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TTTGAGCCTCTACCTT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TTCCAGAAGCGTCTAT 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7249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FBP5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10g086720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TGTTGACTAATCTTAGGCTC 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ATCGTTGACCGACTTTT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7249">
                <a:tc>
                  <a:txBody>
                    <a:bodyPr/>
                    <a:lstStyle/>
                    <a:p>
                      <a:pPr algn="ctr"/>
                      <a:r>
                        <a:rPr lang="en-US" sz="800" b="1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PGK1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Solyc07g066610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TCACCAGCAAATCGTC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等线" panose="02010600030101010101" pitchFamily="2" charset="-122"/>
                          <a:cs typeface="Times New Roman" panose="02020603050405020304" charset="0"/>
                        </a:rPr>
                        <a:t>ATTTCGCCAGATACAACG</a:t>
                      </a: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61487" y="970400"/>
            <a:ext cx="4859846" cy="7112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宋体" panose="02010600030101010101" pitchFamily="2" charset="-122"/>
              </a:rPr>
              <a:t>Table. 6.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Effects of </a:t>
            </a:r>
            <a:r>
              <a:rPr lang="en-US" altLang="zh-CN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FBA1, RCA1, FBP5,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and </a:t>
            </a:r>
            <a:r>
              <a:rPr lang="en-US" altLang="zh-CN" sz="10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PGK1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 silencing on plant height, fresh weight of shoot and leaf area in five-week-old tomato plants </a:t>
            </a:r>
            <a:endParaRPr lang="zh-CN" altLang="zh-CN" sz="1000" kern="0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500" b="1" kern="0" dirty="0">
                <a:solidFill>
                  <a:srgbClr val="000000"/>
                </a:solidFill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endParaRPr lang="zh-CN" altLang="en-US" sz="1500" b="1" kern="0" dirty="0">
              <a:solidFill>
                <a:srgbClr val="000000"/>
              </a:solidFill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graphicFrame>
        <p:nvGraphicFramePr>
          <p:cNvPr id="3" name="表格 2"/>
          <p:cNvGraphicFramePr/>
          <p:nvPr>
            <p:custDataLst>
              <p:tags r:id="rId1"/>
            </p:custDataLst>
          </p:nvPr>
        </p:nvGraphicFramePr>
        <p:xfrm>
          <a:off x="858843" y="1608058"/>
          <a:ext cx="4562238" cy="166124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232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131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633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249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en-US" altLang="en-US" sz="900" b="1">
                        <a:solidFill>
                          <a:srgbClr val="000000"/>
                        </a:solidFill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lant height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</a:t>
                      </a:r>
                    </a:p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(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m)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resh weight of shoot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</a:t>
                      </a:r>
                    </a:p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(g)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eaf area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(cm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</a:t>
                      </a: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)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V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3.2±0.6a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2.1±5.1a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55.6±77.8a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274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V-</a:t>
                      </a: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BA1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8.5±0.5b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2.5±5.5b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7.7±53.2a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34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V-</a:t>
                      </a: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CA1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8.6±1.6b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4.4±5.2b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00.9±90.4a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274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V-</a:t>
                      </a: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BP5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.6±1.0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.6±4.5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02.4±61.2b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61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V-</a:t>
                      </a: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GK1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.1±1.4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.2±5.5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42.4±80.3b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40499" marR="40499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7" name="文本框 4"/>
          <p:cNvSpPr txBox="1"/>
          <p:nvPr/>
        </p:nvSpPr>
        <p:spPr>
          <a:xfrm>
            <a:off x="575345" y="6809005"/>
            <a:ext cx="5329487" cy="861774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Figure 2. Gas exchange parameters as influenced by endogenous </a:t>
            </a:r>
            <a:r>
              <a:rPr lang="en-US" altLang="zh-CN" sz="1000" dirty="0" err="1">
                <a:latin typeface="Times New Roman" panose="02020603050405020304" pitchFamily="18" charset="0"/>
              </a:rPr>
              <a:t>brassinosteroid</a:t>
            </a:r>
            <a:r>
              <a:rPr lang="en-US" altLang="zh-CN" sz="1000" dirty="0">
                <a:latin typeface="Times New Roman" panose="02020603050405020304" pitchFamily="18" charset="0"/>
              </a:rPr>
              <a:t> (BR) levels in tomato plants. (A) Stomatal conductance (Gs). (B) Intercellular CO</a:t>
            </a:r>
            <a:r>
              <a:rPr lang="en-US" altLang="zh-CN" sz="1000" baseline="-25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</a:rPr>
              <a:t> concentration (Ci). (C) Transpiration rate (Tr). The fourth leaf of five-week-old plants was used for the measurement. The data represent the means ±SD of at least four biological replicates. Different letters represent significant differences (P&lt;0.05) according to Tukey’s test.</a:t>
            </a:r>
            <a:endParaRPr lang="zh-CN" altLang="en-US" sz="10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1690156" y="1439647"/>
            <a:ext cx="2609619" cy="5087613"/>
            <a:chOff x="3619" y="1838"/>
            <a:chExt cx="6959" cy="13567"/>
          </a:xfrm>
        </p:grpSpPr>
        <p:graphicFrame>
          <p:nvGraphicFramePr>
            <p:cNvPr id="14" name="对象 13"/>
            <p:cNvGraphicFramePr/>
            <p:nvPr/>
          </p:nvGraphicFramePr>
          <p:xfrm>
            <a:off x="4908" y="6311"/>
            <a:ext cx="5670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4" r:id="rId3" imgW="4023360" imgH="3108960" progId="Origin50.Graph">
                    <p:embed/>
                  </p:oleObj>
                </mc:Choice>
                <mc:Fallback>
                  <p:oleObj r:id="rId3" imgW="4023360" imgH="3108960" progId="Origin50.Graph">
                    <p:embed/>
                    <p:pic>
                      <p:nvPicPr>
                        <p:cNvPr id="14" name="对象 13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908" y="6311"/>
                          <a:ext cx="5670" cy="453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对象 13"/>
            <p:cNvGraphicFramePr/>
            <p:nvPr/>
          </p:nvGraphicFramePr>
          <p:xfrm>
            <a:off x="4908" y="10870"/>
            <a:ext cx="5670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5" r:id="rId5" imgW="4023360" imgH="3108960" progId="Origin50.Graph">
                    <p:embed/>
                  </p:oleObj>
                </mc:Choice>
                <mc:Fallback>
                  <p:oleObj r:id="rId5" imgW="4023360" imgH="3108960" progId="Origin50.Graph">
                    <p:embed/>
                    <p:pic>
                      <p:nvPicPr>
                        <p:cNvPr id="15" name="对象 13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908" y="10870"/>
                          <a:ext cx="5670" cy="453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文本框 2"/>
            <p:cNvSpPr txBox="1"/>
            <p:nvPr/>
          </p:nvSpPr>
          <p:spPr>
            <a:xfrm>
              <a:off x="3619" y="2180"/>
              <a:ext cx="120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710" y="6830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732" y="11252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C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graphicFrame>
          <p:nvGraphicFramePr>
            <p:cNvPr id="2" name="对象 1"/>
            <p:cNvGraphicFramePr/>
            <p:nvPr>
              <p:extLst>
                <p:ext uri="{D42A27DB-BD31-4B8C-83A1-F6EECF244321}">
                  <p14:modId xmlns:p14="http://schemas.microsoft.com/office/powerpoint/2010/main" val="87993823"/>
                </p:ext>
              </p:extLst>
            </p:nvPr>
          </p:nvGraphicFramePr>
          <p:xfrm>
            <a:off x="4909" y="1838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6" r:id="rId7" imgW="4276725" imgH="3023235" progId="Origin50.Graph">
                    <p:embed/>
                  </p:oleObj>
                </mc:Choice>
                <mc:Fallback>
                  <p:oleObj r:id="rId7" imgW="4276725" imgH="3023235" progId="Origin50.Graph">
                    <p:embed/>
                    <p:pic>
                      <p:nvPicPr>
                        <p:cNvPr id="2" name="对象 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909" y="1838"/>
                          <a:ext cx="5669" cy="45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776847" y="1979669"/>
            <a:ext cx="4926363" cy="1700621"/>
            <a:chOff x="873" y="3458"/>
            <a:chExt cx="13137" cy="4535"/>
          </a:xfrm>
        </p:grpSpPr>
        <p:graphicFrame>
          <p:nvGraphicFramePr>
            <p:cNvPr id="5" name="对象 24"/>
            <p:cNvGraphicFramePr/>
            <p:nvPr>
              <p:extLst>
                <p:ext uri="{D42A27DB-BD31-4B8C-83A1-F6EECF244321}">
                  <p14:modId xmlns:p14="http://schemas.microsoft.com/office/powerpoint/2010/main" val="4039137982"/>
                </p:ext>
              </p:extLst>
            </p:nvPr>
          </p:nvGraphicFramePr>
          <p:xfrm>
            <a:off x="2159" y="3458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0" r:id="rId3" imgW="4276725" imgH="3023235" progId="Origin50.Graph">
                    <p:embed/>
                  </p:oleObj>
                </mc:Choice>
                <mc:Fallback>
                  <p:oleObj r:id="rId3" imgW="4276725" imgH="3023235" progId="Origin50.Graph">
                    <p:embed/>
                    <p:pic>
                      <p:nvPicPr>
                        <p:cNvPr id="5" name="对象 24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59" y="3458"/>
                          <a:ext cx="5669" cy="453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5"/>
            <p:cNvGraphicFramePr/>
            <p:nvPr>
              <p:extLst>
                <p:ext uri="{D42A27DB-BD31-4B8C-83A1-F6EECF244321}">
                  <p14:modId xmlns:p14="http://schemas.microsoft.com/office/powerpoint/2010/main" val="3846311939"/>
                </p:ext>
              </p:extLst>
            </p:nvPr>
          </p:nvGraphicFramePr>
          <p:xfrm>
            <a:off x="8341" y="3458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1" r:id="rId5" imgW="4276725" imgH="3023235" progId="Origin50.Graph">
                    <p:embed/>
                  </p:oleObj>
                </mc:Choice>
                <mc:Fallback>
                  <p:oleObj r:id="rId5" imgW="4276725" imgH="3023235" progId="Origin50.Graph">
                    <p:embed/>
                    <p:pic>
                      <p:nvPicPr>
                        <p:cNvPr id="6" name="对象 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341" y="3458"/>
                          <a:ext cx="5669" cy="45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文本框 1"/>
            <p:cNvSpPr txBox="1"/>
            <p:nvPr/>
          </p:nvSpPr>
          <p:spPr>
            <a:xfrm>
              <a:off x="873" y="3798"/>
              <a:ext cx="120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7287" y="3798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594706" y="4159589"/>
            <a:ext cx="523027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Figure 3. Maximum photochemical efficiency of PSII (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/Fm) and antenna excitation transfer efficiency (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’/Fm’) as influenced by endogenous </a:t>
            </a:r>
            <a:r>
              <a:rPr lang="en-US" altLang="zh-CN" sz="1000" dirty="0" err="1">
                <a:latin typeface="Times New Roman" panose="02020603050405020304" pitchFamily="18" charset="0"/>
              </a:rPr>
              <a:t>brassinosteroid</a:t>
            </a:r>
            <a:r>
              <a:rPr lang="en-US" altLang="zh-CN" sz="1000" dirty="0">
                <a:latin typeface="Times New Roman" panose="02020603050405020304" pitchFamily="18" charset="0"/>
              </a:rPr>
              <a:t> (BR) levels in tomato plants. (A) 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/Fm.(B) 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’/Fm’. The fourth leaf of five-week-old plants was used for the measurement. The data represent the means ±SD of four biological replicates. Different letters represent significant differences (P&lt;0.05) according to Tukey’s test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5" name="文本框 1"/>
          <p:cNvSpPr txBox="1"/>
          <p:nvPr/>
        </p:nvSpPr>
        <p:spPr>
          <a:xfrm>
            <a:off x="656938" y="5915236"/>
            <a:ext cx="5166300" cy="1323439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Figure 4. Gas exchange parameters as influenced by BZR1 levels and the application of EBR in tomato plants. (A) Stomatal conductance (Gs). (B) Intercellular CO</a:t>
            </a:r>
            <a:r>
              <a:rPr lang="en-US" altLang="zh-CN" sz="1000" baseline="-25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</a:rPr>
              <a:t> concentration (Ci). (C) Transpiration rate (Tr). Five-week-old </a:t>
            </a:r>
            <a:r>
              <a:rPr lang="en-US" altLang="zh-CN" sz="1000" i="1" dirty="0">
                <a:latin typeface="Times New Roman" panose="02020603050405020304" pitchFamily="18" charset="0"/>
              </a:rPr>
              <a:t>bzr1</a:t>
            </a:r>
            <a:r>
              <a:rPr lang="en-US" altLang="zh-CN" sz="1000" dirty="0">
                <a:latin typeface="Times New Roman" panose="02020603050405020304" pitchFamily="18" charset="0"/>
              </a:rPr>
              <a:t> mutants and wild type (WT; “</a:t>
            </a:r>
            <a:r>
              <a:rPr lang="en-US" altLang="zh-CN" sz="1000" dirty="0" err="1">
                <a:latin typeface="Times New Roman" panose="02020603050405020304" pitchFamily="18" charset="0"/>
              </a:rPr>
              <a:t>Condine</a:t>
            </a:r>
            <a:r>
              <a:rPr lang="en-US" altLang="zh-CN" sz="1000" dirty="0">
                <a:latin typeface="Times New Roman" panose="02020603050405020304" pitchFamily="18" charset="0"/>
              </a:rPr>
              <a:t> Red”) plants were used in this analysis. EBR (200 </a:t>
            </a:r>
            <a:r>
              <a:rPr lang="en-US" altLang="zh-CN" sz="1000" dirty="0" err="1">
                <a:latin typeface="Times New Roman" panose="02020603050405020304" pitchFamily="18" charset="0"/>
              </a:rPr>
              <a:t>nM</a:t>
            </a:r>
            <a:r>
              <a:rPr lang="en-US" altLang="zh-CN" sz="1000" dirty="0">
                <a:latin typeface="Times New Roman" panose="02020603050405020304" pitchFamily="18" charset="0"/>
              </a:rPr>
              <a:t>) was applied at 8:00 in the morning. The fourth leaf of five-week-old plants was used for the measurement. The parameters were determined 24 h after treatment. The data represent the means ±SD of at least four biological replicates. Different letters represent significant differences (P&lt;0.05) according to Tukey’s test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1581183" y="828606"/>
            <a:ext cx="2842280" cy="4990488"/>
            <a:chOff x="2589" y="3076"/>
            <a:chExt cx="7579" cy="13308"/>
          </a:xfrm>
        </p:grpSpPr>
        <p:graphicFrame>
          <p:nvGraphicFramePr>
            <p:cNvPr id="7" name="对象 6"/>
            <p:cNvGraphicFramePr/>
            <p:nvPr/>
          </p:nvGraphicFramePr>
          <p:xfrm>
            <a:off x="4498" y="7417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22" r:id="rId3" imgW="4023360" imgH="3108960" progId="Origin50.Graph">
                    <p:embed/>
                  </p:oleObj>
                </mc:Choice>
                <mc:Fallback>
                  <p:oleObj r:id="rId3" imgW="4023360" imgH="3108960" progId="Origin50.Graph">
                    <p:embed/>
                    <p:pic>
                      <p:nvPicPr>
                        <p:cNvPr id="7" name="对象 6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498" y="7417"/>
                          <a:ext cx="5669" cy="453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文本框 9"/>
            <p:cNvSpPr txBox="1"/>
            <p:nvPr/>
          </p:nvSpPr>
          <p:spPr>
            <a:xfrm>
              <a:off x="2589" y="3314"/>
              <a:ext cx="120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644" y="7689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677" y="12091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C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graphicFrame>
          <p:nvGraphicFramePr>
            <p:cNvPr id="2" name="对象 1"/>
            <p:cNvGraphicFramePr/>
            <p:nvPr/>
          </p:nvGraphicFramePr>
          <p:xfrm>
            <a:off x="4499" y="3076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23" r:id="rId5" imgW="4276725" imgH="3023235" progId="Origin50.Graph">
                    <p:embed/>
                  </p:oleObj>
                </mc:Choice>
                <mc:Fallback>
                  <p:oleObj r:id="rId5" imgW="4276725" imgH="3023235" progId="Origin50.Graph">
                    <p:embed/>
                    <p:pic>
                      <p:nvPicPr>
                        <p:cNvPr id="2" name="对象 1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499" y="3076"/>
                          <a:ext cx="5669" cy="45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对象 3"/>
            <p:cNvGraphicFramePr/>
            <p:nvPr/>
          </p:nvGraphicFramePr>
          <p:xfrm>
            <a:off x="4479" y="11849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24" r:id="rId7" imgW="4276725" imgH="3023235" progId="Origin50.Graph">
                    <p:embed/>
                  </p:oleObj>
                </mc:Choice>
                <mc:Fallback>
                  <p:oleObj r:id="rId7" imgW="4276725" imgH="3023235" progId="Origin50.Graph">
                    <p:embed/>
                    <p:pic>
                      <p:nvPicPr>
                        <p:cNvPr id="4" name="对象 3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479" y="11849"/>
                          <a:ext cx="5669" cy="45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53406" y="1439647"/>
            <a:ext cx="5301737" cy="1700621"/>
            <a:chOff x="423" y="3798"/>
            <a:chExt cx="14138" cy="4535"/>
          </a:xfrm>
        </p:grpSpPr>
        <p:graphicFrame>
          <p:nvGraphicFramePr>
            <p:cNvPr id="5" name="对象 4"/>
            <p:cNvGraphicFramePr/>
            <p:nvPr>
              <p:extLst>
                <p:ext uri="{D42A27DB-BD31-4B8C-83A1-F6EECF244321}">
                  <p14:modId xmlns:p14="http://schemas.microsoft.com/office/powerpoint/2010/main" val="214112337"/>
                </p:ext>
              </p:extLst>
            </p:nvPr>
          </p:nvGraphicFramePr>
          <p:xfrm>
            <a:off x="8892" y="3798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38" r:id="rId3" imgW="4276725" imgH="3023235" progId="Origin50.Graph">
                    <p:embed/>
                  </p:oleObj>
                </mc:Choice>
                <mc:Fallback>
                  <p:oleObj r:id="rId3" imgW="4276725" imgH="3023235" progId="Origin50.Graph">
                    <p:embed/>
                    <p:pic>
                      <p:nvPicPr>
                        <p:cNvPr id="5" name="对象 4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892" y="3798"/>
                          <a:ext cx="5669" cy="45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5"/>
            <p:cNvGraphicFramePr/>
            <p:nvPr>
              <p:extLst>
                <p:ext uri="{D42A27DB-BD31-4B8C-83A1-F6EECF244321}">
                  <p14:modId xmlns:p14="http://schemas.microsoft.com/office/powerpoint/2010/main" val="2723430719"/>
                </p:ext>
              </p:extLst>
            </p:nvPr>
          </p:nvGraphicFramePr>
          <p:xfrm>
            <a:off x="1618" y="3798"/>
            <a:ext cx="5669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39" r:id="rId5" imgW="4276725" imgH="3023235" progId="Origin50.Graph">
                    <p:embed/>
                  </p:oleObj>
                </mc:Choice>
                <mc:Fallback>
                  <p:oleObj r:id="rId5" imgW="4276725" imgH="3023235" progId="Origin50.Graph">
                    <p:embed/>
                    <p:pic>
                      <p:nvPicPr>
                        <p:cNvPr id="6" name="对象 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618" y="3798"/>
                          <a:ext cx="5669" cy="45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文本框 6"/>
            <p:cNvSpPr txBox="1"/>
            <p:nvPr/>
          </p:nvSpPr>
          <p:spPr>
            <a:xfrm>
              <a:off x="423" y="3798"/>
              <a:ext cx="120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7588" y="3798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624951" y="3140268"/>
            <a:ext cx="52302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Figure 5. Maximum photochemical efficiency of PSII (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/Fm) and antenna excitation transfer efficiency (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’/Fm’) as influenced by BZR1 levels and the application of EBR in tomato plants. (A) 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/Fm.(B) 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’/Fm’. EBR (200 </a:t>
            </a:r>
            <a:r>
              <a:rPr lang="en-US" altLang="zh-CN" sz="1000" dirty="0" err="1">
                <a:latin typeface="Times New Roman" panose="02020603050405020304" pitchFamily="18" charset="0"/>
              </a:rPr>
              <a:t>nM</a:t>
            </a:r>
            <a:r>
              <a:rPr lang="en-US" altLang="zh-CN" sz="1000" dirty="0">
                <a:latin typeface="Times New Roman" panose="02020603050405020304" pitchFamily="18" charset="0"/>
              </a:rPr>
              <a:t>) was applied at 8:00 in the morning. The fourth leaf of five-week-old plants was used for the measurement. The parameters were determined 24 h after treatment. The data represent the means ±SD of at least four biological replicates. Different letters represent significant differences (P&lt;0.05) according to Tukey’s test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1"/>
          <p:cNvSpPr txBox="1"/>
          <p:nvPr/>
        </p:nvSpPr>
        <p:spPr>
          <a:xfrm>
            <a:off x="798684" y="6165357"/>
            <a:ext cx="5060181" cy="1169551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Figure 6. Gas exchange parameters as influenced by </a:t>
            </a:r>
            <a:r>
              <a:rPr lang="en-US" altLang="zh-CN" sz="1000" i="1" dirty="0">
                <a:latin typeface="Times New Roman" panose="02020603050405020304" pitchFamily="18" charset="0"/>
              </a:rPr>
              <a:t>FBA1-, RCA1-, FBP5-, </a:t>
            </a:r>
            <a:r>
              <a:rPr lang="en-US" altLang="zh-CN" sz="1000" dirty="0">
                <a:latin typeface="Times New Roman" panose="02020603050405020304" pitchFamily="18" charset="0"/>
              </a:rPr>
              <a:t>and </a:t>
            </a:r>
            <a:r>
              <a:rPr lang="en-US" altLang="zh-CN" sz="1000" i="1" dirty="0">
                <a:latin typeface="Times New Roman" panose="02020603050405020304" pitchFamily="18" charset="0"/>
              </a:rPr>
              <a:t>PGK1- </a:t>
            </a:r>
            <a:r>
              <a:rPr lang="en-US" altLang="zh-CN" sz="1000" dirty="0">
                <a:latin typeface="Times New Roman" panose="02020603050405020304" pitchFamily="18" charset="0"/>
              </a:rPr>
              <a:t>silencing and the application of EBR in tomato plants. (A) Stomatal conductance (Gs). (B) Intercellular CO</a:t>
            </a:r>
            <a:r>
              <a:rPr lang="en-US" altLang="zh-CN" sz="1000" baseline="-25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</a:rPr>
              <a:t> concentration (Ci). (C) Transpiration rate (Tr). EBR (200 </a:t>
            </a:r>
            <a:r>
              <a:rPr lang="en-US" altLang="zh-CN" sz="1000" dirty="0" err="1">
                <a:latin typeface="Times New Roman" panose="02020603050405020304" pitchFamily="18" charset="0"/>
              </a:rPr>
              <a:t>nM</a:t>
            </a:r>
            <a:r>
              <a:rPr lang="en-US" altLang="zh-CN" sz="1000" dirty="0">
                <a:latin typeface="Times New Roman" panose="02020603050405020304" pitchFamily="18" charset="0"/>
              </a:rPr>
              <a:t>) was applied at 8:00 in the morning. The fourth leaf of five-week-old plants was used for the measurement. The parameters were determined 24 h after treatment. The data represent the means ±SD of four biological replicates. Different letters represent significant differences (P&lt;0.05) according to Tukey’s test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754529" y="745121"/>
            <a:ext cx="2637368" cy="5351987"/>
            <a:chOff x="3002" y="2123"/>
            <a:chExt cx="7033" cy="14272"/>
          </a:xfrm>
        </p:grpSpPr>
        <p:graphicFrame>
          <p:nvGraphicFramePr>
            <p:cNvPr id="18433" name="对象 3"/>
            <p:cNvGraphicFramePr/>
            <p:nvPr/>
          </p:nvGraphicFramePr>
          <p:xfrm>
            <a:off x="4365" y="2215"/>
            <a:ext cx="5670" cy="45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70" r:id="rId3" imgW="4276725" imgH="3023235" progId="Origin50.Graph">
                    <p:embed/>
                  </p:oleObj>
                </mc:Choice>
                <mc:Fallback>
                  <p:oleObj r:id="rId3" imgW="4276725" imgH="3023235" progId="Origin50.Graph">
                    <p:embed/>
                    <p:pic>
                      <p:nvPicPr>
                        <p:cNvPr id="18433" name="对象 3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365" y="2215"/>
                          <a:ext cx="5670" cy="4538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434" name="对象 5"/>
            <p:cNvGraphicFramePr/>
            <p:nvPr/>
          </p:nvGraphicFramePr>
          <p:xfrm>
            <a:off x="4365" y="7143"/>
            <a:ext cx="5670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71" r:id="rId5" imgW="4276725" imgH="3023235" progId="Origin50.Graph">
                    <p:embed/>
                  </p:oleObj>
                </mc:Choice>
                <mc:Fallback>
                  <p:oleObj r:id="rId5" imgW="4276725" imgH="3023235" progId="Origin50.Graph">
                    <p:embed/>
                    <p:pic>
                      <p:nvPicPr>
                        <p:cNvPr id="18434" name="对象 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365" y="7143"/>
                          <a:ext cx="5670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435" name="对象 7"/>
            <p:cNvGraphicFramePr/>
            <p:nvPr/>
          </p:nvGraphicFramePr>
          <p:xfrm>
            <a:off x="4365" y="11860"/>
            <a:ext cx="5670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72" r:id="rId7" imgW="4276725" imgH="3023235" progId="Origin50.Graph">
                    <p:embed/>
                  </p:oleObj>
                </mc:Choice>
                <mc:Fallback>
                  <p:oleObj r:id="rId7" imgW="4276725" imgH="3023235" progId="Origin50.Graph">
                    <p:embed/>
                    <p:pic>
                      <p:nvPicPr>
                        <p:cNvPr id="18435" name="对象 7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365" y="11860"/>
                          <a:ext cx="5670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文本框 9"/>
            <p:cNvSpPr txBox="1"/>
            <p:nvPr/>
          </p:nvSpPr>
          <p:spPr>
            <a:xfrm>
              <a:off x="3002" y="2123"/>
              <a:ext cx="120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022" y="7108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022" y="11704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C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702577" y="1739659"/>
            <a:ext cx="4882113" cy="1809746"/>
            <a:chOff x="305" y="4574"/>
            <a:chExt cx="13019" cy="4826"/>
          </a:xfrm>
        </p:grpSpPr>
        <p:graphicFrame>
          <p:nvGraphicFramePr>
            <p:cNvPr id="19457" name="对象 48"/>
            <p:cNvGraphicFramePr/>
            <p:nvPr/>
          </p:nvGraphicFramePr>
          <p:xfrm>
            <a:off x="7654" y="4818"/>
            <a:ext cx="5670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6" r:id="rId3" imgW="4276725" imgH="3023235" progId="Origin50.Graph">
                    <p:embed/>
                  </p:oleObj>
                </mc:Choice>
                <mc:Fallback>
                  <p:oleObj r:id="rId3" imgW="4276725" imgH="3023235" progId="Origin50.Graph">
                    <p:embed/>
                    <p:pic>
                      <p:nvPicPr>
                        <p:cNvPr id="19457" name="对象 48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654" y="4818"/>
                          <a:ext cx="5670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458" name="对象 56"/>
            <p:cNvGraphicFramePr/>
            <p:nvPr/>
          </p:nvGraphicFramePr>
          <p:xfrm>
            <a:off x="1375" y="4865"/>
            <a:ext cx="5670" cy="45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7" r:id="rId5" imgW="4276725" imgH="3023235" progId="Origin50.Graph">
                    <p:embed/>
                  </p:oleObj>
                </mc:Choice>
                <mc:Fallback>
                  <p:oleObj r:id="rId5" imgW="4276725" imgH="3023235" progId="Origin50.Graph">
                    <p:embed/>
                    <p:pic>
                      <p:nvPicPr>
                        <p:cNvPr id="19458" name="对象 56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75" y="4865"/>
                          <a:ext cx="5670" cy="4535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文本框 4"/>
            <p:cNvSpPr txBox="1"/>
            <p:nvPr/>
          </p:nvSpPr>
          <p:spPr>
            <a:xfrm>
              <a:off x="305" y="4574"/>
              <a:ext cx="120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6454" y="4613"/>
              <a:ext cx="1176" cy="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endParaRPr lang="zh-CN" altLang="en-US" sz="15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709810" y="4584814"/>
            <a:ext cx="523027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</a:rPr>
              <a:t>Supplementary Figure 7. Maximum quantum yield of PSII (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/Fm) and antenna excitation transfer efficiency (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’/Fm’) as influenced by </a:t>
            </a:r>
            <a:r>
              <a:rPr lang="en-US" altLang="zh-CN" sz="1000" i="1" dirty="0">
                <a:latin typeface="Times New Roman" panose="02020603050405020304" pitchFamily="18" charset="0"/>
              </a:rPr>
              <a:t>FBA1-, RCA1-, FBP5-, </a:t>
            </a:r>
            <a:r>
              <a:rPr lang="en-US" altLang="zh-CN" sz="1000" dirty="0">
                <a:latin typeface="Times New Roman" panose="02020603050405020304" pitchFamily="18" charset="0"/>
              </a:rPr>
              <a:t>and </a:t>
            </a:r>
            <a:r>
              <a:rPr lang="en-US" altLang="zh-CN" sz="1000" i="1" dirty="0">
                <a:latin typeface="Times New Roman" panose="02020603050405020304" pitchFamily="18" charset="0"/>
              </a:rPr>
              <a:t>PGK1-</a:t>
            </a:r>
            <a:r>
              <a:rPr lang="en-US" altLang="zh-CN" sz="1000" dirty="0">
                <a:latin typeface="Times New Roman" panose="02020603050405020304" pitchFamily="18" charset="0"/>
              </a:rPr>
              <a:t> silencing and the application of EBR in tomato plants. (A) 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/Fm.(B) </a:t>
            </a:r>
            <a:r>
              <a:rPr lang="en-US" altLang="zh-CN" sz="1000" dirty="0" err="1">
                <a:latin typeface="Times New Roman" panose="02020603050405020304" pitchFamily="18" charset="0"/>
              </a:rPr>
              <a:t>Fv</a:t>
            </a:r>
            <a:r>
              <a:rPr lang="en-US" altLang="zh-CN" sz="1000" dirty="0">
                <a:latin typeface="Times New Roman" panose="02020603050405020304" pitchFamily="18" charset="0"/>
              </a:rPr>
              <a:t>’/Fm’. EBR (200 </a:t>
            </a:r>
            <a:r>
              <a:rPr lang="en-US" altLang="zh-CN" sz="1000" dirty="0" err="1">
                <a:latin typeface="Times New Roman" panose="02020603050405020304" pitchFamily="18" charset="0"/>
              </a:rPr>
              <a:t>nM</a:t>
            </a:r>
            <a:r>
              <a:rPr lang="en-US" altLang="zh-CN" sz="1000" dirty="0">
                <a:latin typeface="Times New Roman" panose="02020603050405020304" pitchFamily="18" charset="0"/>
              </a:rPr>
              <a:t>) was applied at 8:00 in the morning. The fourth leaf of five-week-old plants was used for the measurement. The parameters were determined 24 h after treatment. The data represent the means ±SD of four biological replicates. Different letters represent significant differences (P&lt;0.05) according to Tukey’s test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829979615"/>
              </p:ext>
            </p:extLst>
          </p:nvPr>
        </p:nvGraphicFramePr>
        <p:xfrm>
          <a:off x="858828" y="1778306"/>
          <a:ext cx="4705318" cy="179099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472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062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324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6499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78500">
                <a:tc gridSpan="4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able 1 Primers used for VIGS vectors construction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24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s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cession number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orward primers (5’-3’)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everse primers (5’-3’)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24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1</a:t>
                      </a:r>
                      <a:endParaRPr lang="en-US" altLang="en-US" sz="9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1g110360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GAATTCAGTCATCCCCAGTTCTTG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GGTACCTTAGCCTCAGTGTTTTC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24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CA1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9g011080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GAATTCGCTACCTCCATCTCAAC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GGTACCAAGTCCCTTCCATCTGT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24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5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86720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GAATTCCTGCTGTATCTACTGGCTCT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GGTACCTAAACACCATTTCCCAAC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249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GK1</a:t>
                      </a:r>
                      <a:endParaRPr lang="en-US" altLang="en-US" sz="9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7g066610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GAATTCGCGGCATTCCCACCACAT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GGTACCTTCCGGCGAAACCGAGGC</a:t>
                      </a:r>
                      <a:endParaRPr lang="en-US" altLang="en-US" sz="9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858826" y="1139635"/>
            <a:ext cx="4528422" cy="2955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</a:rPr>
              <a:t>Supplementary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1 Primers used for VIGS vectors construction</a:t>
            </a:r>
            <a:endParaRPr lang="zh-CN" altLang="zh-CN" sz="10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/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404727264"/>
              </p:ext>
            </p:extLst>
          </p:nvPr>
        </p:nvGraphicFramePr>
        <p:xfrm>
          <a:off x="554344" y="1863434"/>
          <a:ext cx="5371861" cy="4741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1049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04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95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157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99595">
                <a:tc gridSpan="4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able 2 Primers used for </a:t>
                      </a:r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RT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PCR analysis</a:t>
                      </a:r>
                      <a:endParaRPr lang="en-US" altLang="en-US" sz="10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469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s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cession number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orward primers (5’-3’)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everse primers (5’-3’)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8492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tin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1g00533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TCCCTATTTACGAGGGTTATG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AGTTAAATCACGACCAGCAAG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α-tubulin3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8g00689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AACAGACCGGCATTTTACA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TGATGATGAAGCAGATGG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1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1g11036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CCATGAACCAAGCTCCAAA</a:t>
                      </a:r>
                      <a:endParaRPr lang="en-US" altLang="en-US" sz="8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CAGCCTTCACATTCTCAG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2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2g06234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ATGGCACGTATCGTTCT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GGTGTATTTGCCTAGTTG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3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2g08444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TCGTTCTCATACGCCAG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CCTGAGCTGCCTTCAC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4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5g00860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AACTGCCGGAAAGAGACT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CGCGCAAGACATCAACA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5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5439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ATCTCCAAACCCGTGGC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ACACTCTCAGGGAGTCC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6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7g06590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 GCACTCAATGACCAGCATG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CTCACTCTGTCCTCCTG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7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9g00926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AGACCACCACTCAAGGT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ATTTGGCGAACCTAGCA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8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8357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CACCTGGAGCTCTTCAGT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GGTACCCTTGTCGACTT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2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9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5438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ACATGCGAGAAACTAGAGC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ACTCATCTATCGCCAATATTC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A11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9g059040 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GCAGTTGGTGCCATTTCT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TTCAGCCTTGCTCAGAGG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GK1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7g06661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GCTGATCCTCTCTTCAC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AGCCCTGACGAAGACTT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GK2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7g06660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GCCACTTGTGCCTAGACT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CAGCCACCAAGTTCTCA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GK3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9g00813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GAGCAGAAGAAACAGCA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ATTTGAGAAGCCGCGAGT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BP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5g05260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TCCAACAGCTAAGGCGA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 GGACGGATTGTTTCCCATC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CA1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9g011080 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TCGATAGCTTCCCTGGAC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CCGTACTCGAGGAGCTT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CA2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8658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CCTCAGTGTCAACCATT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GGAAGTTCCAGCAACTG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CA3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3g11785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TAGGGCTGGCGTCATTG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TAGTCACCTTCTGCCG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1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2g05653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GCACTGGACTTAGTTCC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TCTTCAGCAGCATAAAGC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2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4g07134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ACTGCGTGCCCAATCTCT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AGTCTCCACGGGATTCAG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3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9g01181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AGGGACAAACCTTCTTG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CCAGAGCTGGTAGTTTCC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4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8673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GATTGATCAAGCCAGGGA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CGTTTCCTACCGAGAGT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1496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5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10g08672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ACAATGTGGAGCAGAGG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TGAGCACGAAGATCACTG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1624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BP6</a:t>
                      </a:r>
                      <a:endParaRPr lang="en-US" altLang="en-US" sz="8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olyc01g106010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GCTTGTTGCAGCAGCTTAT</a:t>
                      </a:r>
                      <a:endParaRPr lang="en-US" altLang="en-US" sz="8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CTCGAGGAGGAATGTTGA</a:t>
                      </a:r>
                      <a:endParaRPr lang="en-US" altLang="en-US" sz="8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7500" marR="7500" marT="7500" marB="270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901350" y="1097967"/>
            <a:ext cx="3359280" cy="2955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</a:rPr>
              <a:t>Supplementary 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2 Primers used for </a:t>
            </a:r>
            <a:r>
              <a:rPr lang="en-US" altLang="zh-CN" sz="10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10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PCR analysis</a:t>
            </a:r>
            <a:endParaRPr lang="zh-CN" altLang="zh-CN" sz="10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fa242d38-e705-4601-8bf9-c2ea5e36f128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c5737206-6552-446e-813f-95cfac7c314d}"/>
  <p:tag name="TABLE_ENDDRAG_ORIGIN_RECT" val="716*630"/>
  <p:tag name="TABLE_ENDDRAG_RECT" val="1*144*716*630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66b5bf63-073a-49e5-92e2-041d4960fbf2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787b95c2-6bc4-40c7-87a6-f15d81c4d0e7}"/>
  <p:tag name="TABLE_ENDDRAG_ORIGIN_RECT" val="682*263"/>
  <p:tag name="TABLE_ENDDRAG_RECT" val="19*107*682*263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48ab0514-4ac9-4b0b-adf6-2f1c9d57acfa}"/>
  <p:tag name="TABLE_ENDDRAG_ORIGIN_RECT" val="665*181"/>
  <p:tag name="TABLE_ENDDRAG_RECT" val="22*121*665*18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e453e261-9db7-4051-a215-1e970b49c58b}"/>
  <p:tag name="TABLE_ENDDRAG_ORIGIN_RECT" val="608*221"/>
  <p:tag name="TABLE_ENDDRAG_RECT" val="51*111*608*221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</TotalTime>
  <Words>1172</Words>
  <Application>Microsoft Office PowerPoint</Application>
  <PresentationFormat>自定义</PresentationFormat>
  <Paragraphs>251</Paragraphs>
  <Slides>1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20" baseType="lpstr">
      <vt:lpstr>宋体</vt:lpstr>
      <vt:lpstr>Arial</vt:lpstr>
      <vt:lpstr>Calibri</vt:lpstr>
      <vt:lpstr>Calibri Light</vt:lpstr>
      <vt:lpstr>Times New Roman</vt:lpstr>
      <vt:lpstr>Office 主题​​</vt:lpstr>
      <vt:lpstr>Origin50.Graph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 xiaowei</dc:creator>
  <cp:lastModifiedBy>yin xiaowei</cp:lastModifiedBy>
  <cp:revision>8</cp:revision>
  <dcterms:created xsi:type="dcterms:W3CDTF">2021-10-28T10:49:56Z</dcterms:created>
  <dcterms:modified xsi:type="dcterms:W3CDTF">2022-01-06T05:17:09Z</dcterms:modified>
</cp:coreProperties>
</file>